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>
        <p:scale>
          <a:sx n="78" d="100"/>
          <a:sy n="78" d="100"/>
        </p:scale>
        <p:origin x="878" y="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אלעד לקס/Elad Lax" userId="136e56fb-9293-434d-be9b-8f63d8a59b9b" providerId="ADAL" clId="{C1FADDC4-4DC6-40FC-85B7-B36533CB9B23}"/>
    <pc:docChg chg="custSel modSld">
      <pc:chgData name="אלעד לקס/Elad Lax" userId="136e56fb-9293-434d-be9b-8f63d8a59b9b" providerId="ADAL" clId="{C1FADDC4-4DC6-40FC-85B7-B36533CB9B23}" dt="2024-05-14T18:04:23.145" v="365" actId="12788"/>
      <pc:docMkLst>
        <pc:docMk/>
      </pc:docMkLst>
      <pc:sldChg chg="addSp modSp mod">
        <pc:chgData name="אלעד לקס/Elad Lax" userId="136e56fb-9293-434d-be9b-8f63d8a59b9b" providerId="ADAL" clId="{C1FADDC4-4DC6-40FC-85B7-B36533CB9B23}" dt="2024-05-14T18:04:23.145" v="365" actId="12788"/>
        <pc:sldMkLst>
          <pc:docMk/>
          <pc:sldMk cId="1693641646" sldId="257"/>
        </pc:sldMkLst>
        <pc:spChg chg="add mod">
          <ac:chgData name="אלעד לקס/Elad Lax" userId="136e56fb-9293-434d-be9b-8f63d8a59b9b" providerId="ADAL" clId="{C1FADDC4-4DC6-40FC-85B7-B36533CB9B23}" dt="2024-05-14T18:04:23.145" v="365" actId="12788"/>
          <ac:spMkLst>
            <pc:docMk/>
            <pc:sldMk cId="1693641646" sldId="257"/>
            <ac:spMk id="4" creationId="{DD0CC648-88AD-8367-FAD8-25FDD2B75448}"/>
          </ac:spMkLst>
        </pc:spChg>
        <pc:graphicFrameChg chg="mod">
          <ac:chgData name="אלעד לקס/Elad Lax" userId="136e56fb-9293-434d-be9b-8f63d8a59b9b" providerId="ADAL" clId="{C1FADDC4-4DC6-40FC-85B7-B36533CB9B23}" dt="2024-05-14T18:03:53.192" v="360" actId="12788"/>
          <ac:graphicFrameMkLst>
            <pc:docMk/>
            <pc:sldMk cId="1693641646" sldId="257"/>
            <ac:graphicFrameMk id="2" creationId="{71EC2280-B420-7566-0C32-DCEEE8928F40}"/>
          </ac:graphicFrameMkLst>
        </pc:graphicFrame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8D8CAD-D29E-F926-3A8B-F7226CFCD9D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A2430E9-4812-D954-1C11-20779110FC4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DA916E4-1BFA-AEB8-EF71-CF1E925B34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AC5B2-282D-410F-8DF6-5919C447455B}" type="datetimeFigureOut">
              <a:rPr lang="en-US" smtClean="0"/>
              <a:t>5/1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ABCA6DD-55EB-DC40-5ED3-218C3AFBF7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F98F020-B12B-1FEF-AA3F-8257D61E15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BE59C-09C1-4D95-9E84-FEBF09A439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66208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8BBE46-47DB-057E-E953-4DBC19CDAB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71AC38F-E48A-B1B4-FFCF-651B49EA801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56ADBA7-73A4-9FC8-4072-E2C20D0D27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AC5B2-282D-410F-8DF6-5919C447455B}" type="datetimeFigureOut">
              <a:rPr lang="en-US" smtClean="0"/>
              <a:t>5/1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1970E1A-8D48-FB99-2798-B0BF3D6883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8B332C-545D-8951-16B8-EC137ADDC9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BE59C-09C1-4D95-9E84-FEBF09A439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91159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F46CE18-77E8-0F1A-89ED-D71F9331467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4A4BA63-A791-D5D0-70D8-51C1D14C6D8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461CA02-A8AB-5326-B723-A542D5C9F6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AC5B2-282D-410F-8DF6-5919C447455B}" type="datetimeFigureOut">
              <a:rPr lang="en-US" smtClean="0"/>
              <a:t>5/1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A3A0B0F-54EA-1611-1685-B14E0ECD7B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8FFCE36-C37C-A3CD-9024-40FDA64190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BE59C-09C1-4D95-9E84-FEBF09A439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91827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98F5B7-692D-B188-E874-330446E65A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3392E6D-3E24-F02A-033F-451ABDAB50D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3C94C3-2742-BE10-14DB-C977C0A002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AC5B2-282D-410F-8DF6-5919C447455B}" type="datetimeFigureOut">
              <a:rPr lang="en-US" smtClean="0"/>
              <a:t>5/1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A7A85E0-F008-94F2-8B8C-3E3784012F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165C79B-29FC-1371-78D4-26D38494E9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BE59C-09C1-4D95-9E84-FEBF09A439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25698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E6E8BA-4591-CF75-2036-ACC50A9BA1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F86D7C3-785A-1EEE-EEF2-73317776881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70C8CEC-41AD-CBA9-4739-802E9AFF00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AC5B2-282D-410F-8DF6-5919C447455B}" type="datetimeFigureOut">
              <a:rPr lang="en-US" smtClean="0"/>
              <a:t>5/1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16F70E-F9D9-4145-0F84-554A55DDDB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DD981C7-0733-9D30-EA11-D56B6A13C3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BE59C-09C1-4D95-9E84-FEBF09A439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16367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863C85-B3CE-60F6-9BB3-A57FB52C2B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54ECE8E-F677-EFE5-17B1-707A6F122B2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FC64AE0-C25C-CADC-22A3-7D92EC070C1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2616C0E-D9FD-AE77-DEE4-C5A2BA7A08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AC5B2-282D-410F-8DF6-5919C447455B}" type="datetimeFigureOut">
              <a:rPr lang="en-US" smtClean="0"/>
              <a:t>5/14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4FF563B-846F-E194-997F-8E77257A00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B847760-80CC-1EF9-AACB-7279DD199D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BE59C-09C1-4D95-9E84-FEBF09A439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2326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D9DD5B-FCFC-73C2-E1C2-444B8385F8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F7DC67D-A07D-AFA2-1CB7-562D4207DD3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88FF36E-F74A-A1A5-9CA2-9D7FB6260BC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F7392E6-1892-87C8-6AFE-E432E0C3873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3B85913-5139-70E2-85BA-C66FD69B9D3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30FC843-5A41-A7E5-6FFC-9364A386CF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AC5B2-282D-410F-8DF6-5919C447455B}" type="datetimeFigureOut">
              <a:rPr lang="en-US" smtClean="0"/>
              <a:t>5/14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5EB300B-152E-D219-4F80-61083BA45E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33F6539-45A6-4C3B-2EBB-070D0AFBD7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BE59C-09C1-4D95-9E84-FEBF09A439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32271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1730C4-1E56-733A-9666-07F8E68891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0A7B470-5F03-DE84-86DD-20EE75D68D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AC5B2-282D-410F-8DF6-5919C447455B}" type="datetimeFigureOut">
              <a:rPr lang="en-US" smtClean="0"/>
              <a:t>5/14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7EF8885-0050-02D2-520F-86ED0E7B99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9F084DB-86ED-E087-9266-EFC4A4F963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BE59C-09C1-4D95-9E84-FEBF09A439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64364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A9F94EB-36D4-E57B-DE75-D44A5E3A43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AC5B2-282D-410F-8DF6-5919C447455B}" type="datetimeFigureOut">
              <a:rPr lang="en-US" smtClean="0"/>
              <a:t>5/14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6989D6C-DF3F-ECB1-591F-D4438FB17D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7A23280-F9FA-A3F9-5801-3FF2DC7DC0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BE59C-09C1-4D95-9E84-FEBF09A439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61437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29B90D-D054-5A79-3CD7-9E8E69D82B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02C146C-FF16-A2E0-9EE1-6D125F8A54A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647E5A7-8333-25CC-7844-E5636B77B73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5BC64C5-9B9D-10B6-C1E3-C9CA7862A7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AC5B2-282D-410F-8DF6-5919C447455B}" type="datetimeFigureOut">
              <a:rPr lang="en-US" smtClean="0"/>
              <a:t>5/14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C79654F-F523-556A-DE78-AB8E7D77FC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D0B3D64-CD35-401B-2BCC-5D1D3D2021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BE59C-09C1-4D95-9E84-FEBF09A439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42195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D27AB2-A5A0-53D1-74E9-375A621CB9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3EC0849-CFAC-7454-C400-C795487B46E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F4AD3F8-9D89-D3F5-BB74-37EB8B072EB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55C797A-F8A2-FBA6-5E42-0ADAD19242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AC5B2-282D-410F-8DF6-5919C447455B}" type="datetimeFigureOut">
              <a:rPr lang="en-US" smtClean="0"/>
              <a:t>5/14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56F0C4A-2C74-D141-E2D8-2AAA45ACDA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CB7B9B8-7B9C-323C-BD1B-08347BE24D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BE59C-09C1-4D95-9E84-FEBF09A439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48141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0C22DCD-47A2-BA84-BC6C-FE821D45A0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040FAEA-01B2-2A44-F402-5A16FD12179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0442DE6-15CB-ABF8-8472-CEA19FE0519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85AC5B2-282D-410F-8DF6-5919C447455B}" type="datetimeFigureOut">
              <a:rPr lang="en-US" smtClean="0"/>
              <a:t>5/1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F1D394-86F0-3DF5-DFBD-32F38922864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9CEE56-5BF3-63B1-E87B-A771A33C654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3CBE59C-09C1-4D95-9E84-FEBF09A439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89052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71EC2280-B420-7566-0C32-DCEEE8928F4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77669975"/>
              </p:ext>
            </p:extLst>
          </p:nvPr>
        </p:nvGraphicFramePr>
        <p:xfrm>
          <a:off x="1951831" y="39339"/>
          <a:ext cx="8288338" cy="61372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8287947" imgH="6136626" progId="Prism10.Document">
                  <p:embed/>
                </p:oleObj>
              </mc:Choice>
              <mc:Fallback>
                <p:oleObj name="Prism 10" r:id="rId2" imgW="8287947" imgH="6136626" progId="Prism10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71EC2280-B420-7566-0C32-DCEEE8928F4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951831" y="39339"/>
                        <a:ext cx="8288338" cy="61372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DD0CC648-88AD-8367-FAD8-25FDD2B75448}"/>
              </a:ext>
            </a:extLst>
          </p:cNvPr>
          <p:cNvSpPr txBox="1"/>
          <p:nvPr/>
        </p:nvSpPr>
        <p:spPr>
          <a:xfrm>
            <a:off x="1125794" y="5864219"/>
            <a:ext cx="9940412" cy="8891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gure 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1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: </a:t>
            </a:r>
            <a:r>
              <a:rPr lang="en-US" sz="1200" b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ARylation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enrichment on Egr1-3 promoters. 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AR fold enrichment on Egr2 promoter was significantly reduced 15 minutes after the FST in ABT888 pretreated mice. No significant differences were observed 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or Egr1 and Egr3. One hour after the FST there were no significant differences for Egr1 and Egr3, and no </a:t>
            </a:r>
            <a:r>
              <a:rPr lang="en-US" sz="1200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ARylation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was detected for Egr2. 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-test, *p&lt;0,05, n=4 per group in all cases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936416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78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Office Theme</vt:lpstr>
      <vt:lpstr>Prism 10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אלעד לקס/Elad Lax</dc:creator>
  <cp:lastModifiedBy>אלעד לקס/Elad Lax</cp:lastModifiedBy>
  <cp:revision>1</cp:revision>
  <dcterms:created xsi:type="dcterms:W3CDTF">2024-05-14T08:25:11Z</dcterms:created>
  <dcterms:modified xsi:type="dcterms:W3CDTF">2024-05-14T18:04:27Z</dcterms:modified>
</cp:coreProperties>
</file>